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ustomXml" Target="../customXml/item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37452"/>
            <a:ext cx="8392568" cy="585854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53143" y="5410200"/>
            <a:ext cx="8469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of the distributions of nine main phyla among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32972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70479"/>
            <a:ext cx="8850086" cy="617792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3400" y="6103203"/>
            <a:ext cx="84690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of the relative abundances of eight main phyla and four main classe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bacter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riplicate samples from two sampling periods were pooled. Significances of the differences among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tested using one-way ANOVA, followed by Turkey HSD pairwise group comparisons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3606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33400" y="6072901"/>
            <a:ext cx="84690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s of the relative abundances of six main genera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bacter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ong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riplicate samples from two sampling times were pooled. Significances of the differences among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tested using one-way ANOVA, followed by Turkey HSD pairwise group comparisons.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6024" y="195878"/>
            <a:ext cx="8310775" cy="5877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76732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029" y="0"/>
            <a:ext cx="8719457" cy="608673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3400" y="6072901"/>
            <a:ext cx="84690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tions in relative abundances of eight main phyla and four main classe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bacter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ong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nosequen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ymbols shown in inset legend at upper right corner). The polynomial models were performed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ginP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.5 software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70508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004" y="195878"/>
            <a:ext cx="8637196" cy="61078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33400" y="6072901"/>
            <a:ext cx="84690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tions in relative abundances of six main genera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obacteri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ong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onosequen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he bulk soil, rhizosphere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phe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olynomial models were perform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iginP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.5 softwar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5952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D2C91247-35C8-48DC-8329-35239B14ABAB}"/>
</file>

<file path=customXml/itemProps2.xml><?xml version="1.0" encoding="utf-8"?>
<ds:datastoreItem xmlns:ds="http://schemas.openxmlformats.org/officeDocument/2006/customXml" ds:itemID="{99BA89D1-5733-41B8-A0DF-2329122AC0CD}"/>
</file>

<file path=customXml/itemProps3.xml><?xml version="1.0" encoding="utf-8"?>
<ds:datastoreItem xmlns:ds="http://schemas.openxmlformats.org/officeDocument/2006/customXml" ds:itemID="{E27D8E3F-651E-4C8F-B8C1-1DFA9F85CC9E}"/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21</Words>
  <Application>Microsoft Office PowerPoint</Application>
  <PresentationFormat>On-screen Show (4:3)</PresentationFormat>
  <Paragraphs>7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. Wang</dc:creator>
  <cp:lastModifiedBy>M. Wang</cp:lastModifiedBy>
  <cp:revision>3</cp:revision>
  <dcterms:created xsi:type="dcterms:W3CDTF">2006-08-16T00:00:00Z</dcterms:created>
  <dcterms:modified xsi:type="dcterms:W3CDTF">2015-07-15T14:5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